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248C3E4-9239-D604-9635-C5EA8AF55C0D}" name="James Burns" initials="JB" userId="S::je.burns@mail.utoronto.ca::e28dd781-7100-42e5-b0c1-7d4c6953c02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35" autoAdjust="0"/>
    <p:restoredTop sz="94660"/>
  </p:normalViewPr>
  <p:slideViewPr>
    <p:cSldViewPr snapToGrid="0">
      <p:cViewPr varScale="1">
        <p:scale>
          <a:sx n="67" d="100"/>
          <a:sy n="67" d="100"/>
        </p:scale>
        <p:origin x="128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52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89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745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8317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552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511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64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95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944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17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824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86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5BA7AFD0-72E2-CB05-C7E9-A1CF82124B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2566" y="281939"/>
            <a:ext cx="4050000" cy="324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D405338-A80F-5ACD-6B6F-571E04DCC6F4}"/>
              </a:ext>
            </a:extLst>
          </p:cNvPr>
          <p:cNvSpPr txBox="1"/>
          <p:nvPr/>
        </p:nvSpPr>
        <p:spPr>
          <a:xfrm>
            <a:off x="287958" y="119080"/>
            <a:ext cx="4341192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DC 10: Figure 7S(a-c): Bone turnover marker - P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ocollagen Type 1 N terminal </a:t>
            </a:r>
            <a:r>
              <a:rPr lang="en-GB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ropeptide</a:t>
            </a:r>
            <a:endParaRPr lang="en-GB" sz="18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ntermediate values vs. baseline*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ngitudinal changes TAF vs. TDF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Percentage changes TAF vs. TDF</a:t>
            </a:r>
          </a:p>
          <a:p>
            <a:pPr marL="342900" indent="-342900" algn="just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TAF: red, TDF: blue</a:t>
            </a:r>
          </a:p>
          <a:p>
            <a:pPr algn="just"/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me relates to the date of the first measurement of the parameter in questi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1NP: procollagen Type 1 N terminal </a:t>
            </a:r>
            <a:r>
              <a:rPr lang="en-GB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ropeptid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TAF: tenofovir alafenamide fumarate, TDF: tenofovir disoproxil fumarate.</a:t>
            </a:r>
          </a:p>
          <a:p>
            <a:pPr marL="342900" indent="-342900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4FB4C1-6886-C5B6-2F56-7D3DD24878D0}"/>
              </a:ext>
            </a:extLst>
          </p:cNvPr>
          <p:cNvSpPr txBox="1"/>
          <p:nvPr/>
        </p:nvSpPr>
        <p:spPr>
          <a:xfrm>
            <a:off x="4371975" y="1143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753C4D-4ECA-84CF-1704-64134EED93C3}"/>
              </a:ext>
            </a:extLst>
          </p:cNvPr>
          <p:cNvSpPr txBox="1"/>
          <p:nvPr/>
        </p:nvSpPr>
        <p:spPr>
          <a:xfrm>
            <a:off x="295275" y="3394345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63E658-B0AE-5C26-ACC0-06644E1390BE}"/>
              </a:ext>
            </a:extLst>
          </p:cNvPr>
          <p:cNvSpPr txBox="1"/>
          <p:nvPr/>
        </p:nvSpPr>
        <p:spPr>
          <a:xfrm>
            <a:off x="4429328" y="3424137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4" name="Picture 3" descr="Chart, line chart&#10;&#10;Description automatically generated">
            <a:extLst>
              <a:ext uri="{FF2B5EF4-FFF2-40B4-BE49-F238E27FC236}">
                <a16:creationId xmlns:a16="http://schemas.microsoft.com/office/drawing/2014/main" id="{65966E51-3FC2-3036-D6D9-C8F52B5564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075" y="3809762"/>
            <a:ext cx="3771900" cy="2743200"/>
          </a:xfrm>
          <a:prstGeom prst="rect">
            <a:avLst/>
          </a:prstGeom>
        </p:spPr>
      </p:pic>
      <p:pic>
        <p:nvPicPr>
          <p:cNvPr id="12" name="Picture 11" descr="Chart&#10;&#10;Description automatically generated">
            <a:extLst>
              <a:ext uri="{FF2B5EF4-FFF2-40B4-BE49-F238E27FC236}">
                <a16:creationId xmlns:a16="http://schemas.microsoft.com/office/drawing/2014/main" id="{2E6DC9B6-57B5-94E2-B9A8-0C537D44D44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0666" y="3832861"/>
            <a:ext cx="377190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8179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0</TotalTime>
  <Words>88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ort diagram?</dc:title>
  <dc:creator>David Dunn</dc:creator>
  <cp:lastModifiedBy>Arun Sharma</cp:lastModifiedBy>
  <cp:revision>26</cp:revision>
  <dcterms:created xsi:type="dcterms:W3CDTF">2022-04-11T09:37:24Z</dcterms:created>
  <dcterms:modified xsi:type="dcterms:W3CDTF">2024-02-29T09:23:39Z</dcterms:modified>
</cp:coreProperties>
</file>